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0" autoAdjust="0"/>
    <p:restoredTop sz="94660"/>
  </p:normalViewPr>
  <p:slideViewPr>
    <p:cSldViewPr snapToGrid="0" showGuides="1">
      <p:cViewPr varScale="1">
        <p:scale>
          <a:sx n="114" d="100"/>
          <a:sy n="114" d="100"/>
        </p:scale>
        <p:origin x="186" y="1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A220A-99D9-4FA4-8557-EEA03DBDD555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B4925-8488-4A75-9F7F-BE753201368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380019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A220A-99D9-4FA4-8557-EEA03DBDD555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B4925-8488-4A75-9F7F-BE753201368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36037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A220A-99D9-4FA4-8557-EEA03DBDD555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B4925-8488-4A75-9F7F-BE753201368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72957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A220A-99D9-4FA4-8557-EEA03DBDD555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B4925-8488-4A75-9F7F-BE753201368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903150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A220A-99D9-4FA4-8557-EEA03DBDD555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B4925-8488-4A75-9F7F-BE753201368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613633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A220A-99D9-4FA4-8557-EEA03DBDD555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B4925-8488-4A75-9F7F-BE753201368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09545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A220A-99D9-4FA4-8557-EEA03DBDD555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B4925-8488-4A75-9F7F-BE753201368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50836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A220A-99D9-4FA4-8557-EEA03DBDD555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B4925-8488-4A75-9F7F-BE753201368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80263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A220A-99D9-4FA4-8557-EEA03DBDD555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B4925-8488-4A75-9F7F-BE753201368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63943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A220A-99D9-4FA4-8557-EEA03DBDD555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B4925-8488-4A75-9F7F-BE753201368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870440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A220A-99D9-4FA4-8557-EEA03DBDD555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B4925-8488-4A75-9F7F-BE753201368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411767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8A220A-99D9-4FA4-8557-EEA03DBDD555}" type="datetimeFigureOut">
              <a:rPr lang="es-ES" smtClean="0"/>
              <a:t>13/08/2024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8B4925-8488-4A75-9F7F-BE753201368C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30626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Imagen 1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4100" y="474002"/>
            <a:ext cx="11880000" cy="6288714"/>
          </a:xfrm>
          <a:prstGeom prst="rect">
            <a:avLst/>
          </a:prstGeom>
        </p:spPr>
      </p:pic>
      <p:sp>
        <p:nvSpPr>
          <p:cNvPr id="18" name="CuadroTexto 3">
            <a:extLst>
              <a:ext uri="{FF2B5EF4-FFF2-40B4-BE49-F238E27FC236}">
                <a16:creationId xmlns:a16="http://schemas.microsoft.com/office/drawing/2014/main" id="{8E5080EB-DC3D-F792-C1B6-9295FB59C127}"/>
              </a:ext>
            </a:extLst>
          </p:cNvPr>
          <p:cNvSpPr txBox="1"/>
          <p:nvPr/>
        </p:nvSpPr>
        <p:spPr>
          <a:xfrm>
            <a:off x="0" y="0"/>
            <a:ext cx="12174166" cy="415498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sz="1050" b="1" dirty="0"/>
              <a:t>Figure S2. </a:t>
            </a:r>
            <a:r>
              <a:rPr lang="en-US" sz="1050" b="0" dirty="0"/>
              <a:t>QTLs linked to ToLCNDV resistance detected with </a:t>
            </a:r>
            <a:r>
              <a:rPr lang="en-US" sz="1050" b="0" dirty="0" err="1"/>
              <a:t>qGene</a:t>
            </a:r>
            <a:r>
              <a:rPr lang="en-US" sz="1050" b="0" dirty="0"/>
              <a:t> software using the F</a:t>
            </a:r>
            <a:r>
              <a:rPr lang="en-US" sz="1050" b="0" baseline="-25000" dirty="0"/>
              <a:t>2</a:t>
            </a:r>
            <a:r>
              <a:rPr lang="en-US" sz="1050" b="0" dirty="0"/>
              <a:t> population derived from the cross PI 414723 × PS ‘Piñonet’ for </a:t>
            </a:r>
            <a:r>
              <a:rPr lang="en-US" sz="1050" dirty="0"/>
              <a:t>four</a:t>
            </a:r>
            <a:r>
              <a:rPr lang="en-US" sz="1050" b="0" dirty="0"/>
              <a:t> traits:</a:t>
            </a:r>
            <a:r>
              <a:rPr lang="en-GB" sz="1050" b="0" dirty="0"/>
              <a:t> A) symptoms at 9 dpi, B) symptoms at 15 dpi, C) symptoms at 30 dpi and D) virus </a:t>
            </a:r>
            <a:r>
              <a:rPr lang="en-GB" sz="1050" b="0" dirty="0" err="1"/>
              <a:t>titer</a:t>
            </a:r>
            <a:r>
              <a:rPr lang="en-GB" sz="1050" b="0" dirty="0"/>
              <a:t> at 30 dpi. The horizontal yellow line indicates the LOD drop of 1.5 threshold. </a:t>
            </a:r>
            <a:r>
              <a:rPr lang="en-GB" sz="1050" dirty="0"/>
              <a:t>No significant QTL detected for traits where the yellow line was not represented.</a:t>
            </a:r>
            <a:endParaRPr lang="en-GB" sz="1050" b="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187C69E-2456-3808-0230-92A1682087FA}"/>
              </a:ext>
            </a:extLst>
          </p:cNvPr>
          <p:cNvSpPr txBox="1"/>
          <p:nvPr/>
        </p:nvSpPr>
        <p:spPr>
          <a:xfrm>
            <a:off x="-51900" y="396448"/>
            <a:ext cx="609600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dirty="0"/>
              <a:t>a</a:t>
            </a:r>
            <a:r>
              <a:rPr lang="en-GB" sz="1100" b="0" dirty="0"/>
              <a:t>)</a:t>
            </a:r>
            <a:endParaRPr lang="en-US" sz="11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CEFD771-587E-1F90-A579-1CD48117396D}"/>
              </a:ext>
            </a:extLst>
          </p:cNvPr>
          <p:cNvSpPr txBox="1"/>
          <p:nvPr/>
        </p:nvSpPr>
        <p:spPr>
          <a:xfrm>
            <a:off x="-51900" y="2034659"/>
            <a:ext cx="6119812" cy="2539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050" dirty="0"/>
              <a:t>b</a:t>
            </a:r>
            <a:r>
              <a:rPr lang="en-GB" sz="1050" b="0" dirty="0"/>
              <a:t>)</a:t>
            </a:r>
            <a:endParaRPr lang="en-US" sz="105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D2A8A07-DF8E-EDAF-1E5E-93C244105B6B}"/>
              </a:ext>
            </a:extLst>
          </p:cNvPr>
          <p:cNvSpPr txBox="1"/>
          <p:nvPr/>
        </p:nvSpPr>
        <p:spPr>
          <a:xfrm>
            <a:off x="-63806" y="3665176"/>
            <a:ext cx="611981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dirty="0"/>
              <a:t>c</a:t>
            </a:r>
            <a:r>
              <a:rPr lang="en-GB" sz="1100" b="0" dirty="0"/>
              <a:t>)</a:t>
            </a:r>
            <a:endParaRPr lang="en-US" sz="11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46ACA46-CED1-3217-6A9F-8B3371182A79}"/>
              </a:ext>
            </a:extLst>
          </p:cNvPr>
          <p:cNvSpPr txBox="1"/>
          <p:nvPr/>
        </p:nvSpPr>
        <p:spPr>
          <a:xfrm>
            <a:off x="-61424" y="5303387"/>
            <a:ext cx="6129336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dirty="0"/>
              <a:t>d</a:t>
            </a:r>
            <a:r>
              <a:rPr lang="en-GB" sz="1100" b="0"/>
              <a:t>) 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223512267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</TotalTime>
  <Words>94</Words>
  <Application>Microsoft Office PowerPoint</Application>
  <PresentationFormat>Panorámica</PresentationFormat>
  <Paragraphs>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HP Inc.</dc:creator>
  <cp:lastModifiedBy>Clara Perez Moro</cp:lastModifiedBy>
  <cp:revision>8</cp:revision>
  <dcterms:created xsi:type="dcterms:W3CDTF">2024-08-02T15:18:52Z</dcterms:created>
  <dcterms:modified xsi:type="dcterms:W3CDTF">2024-08-13T17:13:51Z</dcterms:modified>
</cp:coreProperties>
</file>